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2" d="100"/>
          <a:sy n="62" d="100"/>
        </p:scale>
        <p:origin x="-714" y="-13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77317-DEFB-43C9-B63F-9D1A16D761F0}" type="datetimeFigureOut">
              <a:rPr lang="en-US" smtClean="0"/>
              <a:t>3/2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D6A5-F378-4729-B33F-088E63600A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5254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77317-DEFB-43C9-B63F-9D1A16D761F0}" type="datetimeFigureOut">
              <a:rPr lang="en-US" smtClean="0"/>
              <a:t>3/2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D6A5-F378-4729-B33F-088E63600A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321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77317-DEFB-43C9-B63F-9D1A16D761F0}" type="datetimeFigureOut">
              <a:rPr lang="en-US" smtClean="0"/>
              <a:t>3/2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D6A5-F378-4729-B33F-088E63600A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6911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77317-DEFB-43C9-B63F-9D1A16D761F0}" type="datetimeFigureOut">
              <a:rPr lang="en-US" smtClean="0"/>
              <a:t>3/2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D6A5-F378-4729-B33F-088E63600A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112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77317-DEFB-43C9-B63F-9D1A16D761F0}" type="datetimeFigureOut">
              <a:rPr lang="en-US" smtClean="0"/>
              <a:t>3/2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D6A5-F378-4729-B33F-088E63600A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166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77317-DEFB-43C9-B63F-9D1A16D761F0}" type="datetimeFigureOut">
              <a:rPr lang="en-US" smtClean="0"/>
              <a:t>3/2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D6A5-F378-4729-B33F-088E63600A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139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77317-DEFB-43C9-B63F-9D1A16D761F0}" type="datetimeFigureOut">
              <a:rPr lang="en-US" smtClean="0"/>
              <a:t>3/2/2017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D6A5-F378-4729-B33F-088E63600A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41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77317-DEFB-43C9-B63F-9D1A16D761F0}" type="datetimeFigureOut">
              <a:rPr lang="en-US" smtClean="0"/>
              <a:t>3/2/2017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D6A5-F378-4729-B33F-088E63600A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658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77317-DEFB-43C9-B63F-9D1A16D761F0}" type="datetimeFigureOut">
              <a:rPr lang="en-US" smtClean="0"/>
              <a:t>3/2/2017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D6A5-F378-4729-B33F-088E63600A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856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77317-DEFB-43C9-B63F-9D1A16D761F0}" type="datetimeFigureOut">
              <a:rPr lang="en-US" smtClean="0"/>
              <a:t>3/2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D6A5-F378-4729-B33F-088E63600A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07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77317-DEFB-43C9-B63F-9D1A16D761F0}" type="datetimeFigureOut">
              <a:rPr lang="en-US" smtClean="0"/>
              <a:t>3/2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D6A5-F378-4729-B33F-088E63600A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347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677317-DEFB-43C9-B63F-9D1A16D761F0}" type="datetimeFigureOut">
              <a:rPr lang="en-US" smtClean="0"/>
              <a:t>3/2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FCD6A5-F378-4729-B33F-088E63600A8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372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ieren 6"/>
          <p:cNvGrpSpPr/>
          <p:nvPr/>
        </p:nvGrpSpPr>
        <p:grpSpPr>
          <a:xfrm>
            <a:off x="15114" y="-1419"/>
            <a:ext cx="9128886" cy="6864184"/>
            <a:chOff x="15114" y="-1419"/>
            <a:chExt cx="9128886" cy="6864184"/>
          </a:xfrm>
        </p:grpSpPr>
        <p:pic>
          <p:nvPicPr>
            <p:cNvPr id="4" name="Grafik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114" y="-1419"/>
              <a:ext cx="9125712" cy="5876544"/>
            </a:xfrm>
            <a:prstGeom prst="rect">
              <a:avLst/>
            </a:prstGeom>
          </p:spPr>
        </p:pic>
        <p:sp>
          <p:nvSpPr>
            <p:cNvPr id="5" name="Textfeld 4"/>
            <p:cNvSpPr txBox="1"/>
            <p:nvPr/>
          </p:nvSpPr>
          <p:spPr>
            <a:xfrm>
              <a:off x="15114" y="5924046"/>
              <a:ext cx="9128886" cy="9387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err="1" smtClean="0"/>
                <a:t>Suppl</a:t>
              </a:r>
              <a:r>
                <a:rPr lang="en-US" sz="1100" b="1" dirty="0" smtClean="0"/>
                <a:t> </a:t>
              </a:r>
              <a:r>
                <a:rPr lang="en-US" sz="1100" b="1" dirty="0"/>
                <a:t>Figure </a:t>
              </a:r>
              <a:r>
                <a:rPr lang="en-US" sz="1100" b="1" dirty="0" smtClean="0"/>
                <a:t>S1</a:t>
              </a:r>
              <a:r>
                <a:rPr lang="en-US" sz="1100" b="1" dirty="0"/>
                <a:t>: Genome-wide coverage segmentation derived from resequencing data from four mapping parents across the 19 chromosomes of the </a:t>
              </a:r>
              <a:r>
                <a:rPr lang="en-US" sz="1100" b="1" i="1" dirty="0"/>
                <a:t>B. napus</a:t>
              </a:r>
              <a:r>
                <a:rPr lang="en-US" sz="1100" b="1" dirty="0"/>
                <a:t> A and C subgenomes.</a:t>
              </a:r>
              <a:r>
                <a:rPr lang="en-US" sz="1100" dirty="0"/>
                <a:t> The images show segments indicated either as putatively duplicated (blue) or putatively deleted (red) identified by applying a segmentation algorithm on genome-wide resequencing data.</a:t>
              </a:r>
              <a:r>
                <a:rPr lang="en-US" sz="1100" b="1" dirty="0"/>
                <a:t> </a:t>
              </a:r>
              <a:r>
                <a:rPr lang="en-US" sz="1100" dirty="0"/>
                <a:t>Regions where a large putative segmental deletion (&gt;500kb) matches a corresponding putative segmental duplication of the homoeologous segment are marked with black arrows as putative homoeologous exchanges (HE). Centromere positions are displayed according to Mason et al. (2013).</a:t>
              </a:r>
              <a:r>
                <a:rPr lang="en-US" sz="1100" b="1" dirty="0"/>
                <a:t>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5373573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3</Words>
  <Application>Microsoft Office PowerPoint</Application>
  <PresentationFormat>Bildschirmpräsentatio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JL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S</dc:creator>
  <cp:lastModifiedBy>AS</cp:lastModifiedBy>
  <cp:revision>2</cp:revision>
  <dcterms:created xsi:type="dcterms:W3CDTF">2017-02-20T11:36:32Z</dcterms:created>
  <dcterms:modified xsi:type="dcterms:W3CDTF">2017-03-02T10:02:10Z</dcterms:modified>
</cp:coreProperties>
</file>